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514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F5825-036B-4DA7-85AA-FD1B934D84E4}" type="datetimeFigureOut">
              <a:rPr lang="ko-KR" altLang="en-US" smtClean="0"/>
              <a:t>2022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CA8F-16AD-4A14-BB0D-0159FB2C7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6044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F5825-036B-4DA7-85AA-FD1B934D84E4}" type="datetimeFigureOut">
              <a:rPr lang="ko-KR" altLang="en-US" smtClean="0"/>
              <a:t>2022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CA8F-16AD-4A14-BB0D-0159FB2C7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7167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F5825-036B-4DA7-85AA-FD1B934D84E4}" type="datetimeFigureOut">
              <a:rPr lang="ko-KR" altLang="en-US" smtClean="0"/>
              <a:t>2022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CA8F-16AD-4A14-BB0D-0159FB2C7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4280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F5825-036B-4DA7-85AA-FD1B934D84E4}" type="datetimeFigureOut">
              <a:rPr lang="ko-KR" altLang="en-US" smtClean="0"/>
              <a:t>2022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CA8F-16AD-4A14-BB0D-0159FB2C7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4634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F5825-036B-4DA7-85AA-FD1B934D84E4}" type="datetimeFigureOut">
              <a:rPr lang="ko-KR" altLang="en-US" smtClean="0"/>
              <a:t>2022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CA8F-16AD-4A14-BB0D-0159FB2C7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3639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F5825-036B-4DA7-85AA-FD1B934D84E4}" type="datetimeFigureOut">
              <a:rPr lang="ko-KR" altLang="en-US" smtClean="0"/>
              <a:t>2022-0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CA8F-16AD-4A14-BB0D-0159FB2C7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07531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F5825-036B-4DA7-85AA-FD1B934D84E4}" type="datetimeFigureOut">
              <a:rPr lang="ko-KR" altLang="en-US" smtClean="0"/>
              <a:t>2022-02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CA8F-16AD-4A14-BB0D-0159FB2C7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3656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F5825-036B-4DA7-85AA-FD1B934D84E4}" type="datetimeFigureOut">
              <a:rPr lang="ko-KR" altLang="en-US" smtClean="0"/>
              <a:t>2022-02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CA8F-16AD-4A14-BB0D-0159FB2C7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3038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F5825-036B-4DA7-85AA-FD1B934D84E4}" type="datetimeFigureOut">
              <a:rPr lang="ko-KR" altLang="en-US" smtClean="0"/>
              <a:t>2022-02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CA8F-16AD-4A14-BB0D-0159FB2C7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6033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F5825-036B-4DA7-85AA-FD1B934D84E4}" type="datetimeFigureOut">
              <a:rPr lang="ko-KR" altLang="en-US" smtClean="0"/>
              <a:t>2022-0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CA8F-16AD-4A14-BB0D-0159FB2C7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9762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F5825-036B-4DA7-85AA-FD1B934D84E4}" type="datetimeFigureOut">
              <a:rPr lang="ko-KR" altLang="en-US" smtClean="0"/>
              <a:t>2022-0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FCA8F-16AD-4A14-BB0D-0159FB2C7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37003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CF5825-036B-4DA7-85AA-FD1B934D84E4}" type="datetimeFigureOut">
              <a:rPr lang="ko-KR" altLang="en-US" smtClean="0"/>
              <a:t>2022-0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7FCA8F-16AD-4A14-BB0D-0159FB2C7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2772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8023152"/>
              </p:ext>
            </p:extLst>
          </p:nvPr>
        </p:nvGraphicFramePr>
        <p:xfrm>
          <a:off x="1749951" y="1714953"/>
          <a:ext cx="8634916" cy="2857313"/>
        </p:xfrm>
        <a:graphic>
          <a:graphicData uri="http://schemas.openxmlformats.org/drawingml/2006/table">
            <a:tbl>
              <a:tblPr/>
              <a:tblGrid>
                <a:gridCol w="1267736">
                  <a:extLst>
                    <a:ext uri="{9D8B030D-6E8A-4147-A177-3AD203B41FA5}">
                      <a16:colId xmlns:a16="http://schemas.microsoft.com/office/drawing/2014/main" val="4261025123"/>
                    </a:ext>
                  </a:extLst>
                </a:gridCol>
                <a:gridCol w="400001">
                  <a:extLst>
                    <a:ext uri="{9D8B030D-6E8A-4147-A177-3AD203B41FA5}">
                      <a16:colId xmlns:a16="http://schemas.microsoft.com/office/drawing/2014/main" val="4068494634"/>
                    </a:ext>
                  </a:extLst>
                </a:gridCol>
                <a:gridCol w="774131">
                  <a:extLst>
                    <a:ext uri="{9D8B030D-6E8A-4147-A177-3AD203B41FA5}">
                      <a16:colId xmlns:a16="http://schemas.microsoft.com/office/drawing/2014/main" val="2429761926"/>
                    </a:ext>
                  </a:extLst>
                </a:gridCol>
                <a:gridCol w="774131">
                  <a:extLst>
                    <a:ext uri="{9D8B030D-6E8A-4147-A177-3AD203B41FA5}">
                      <a16:colId xmlns:a16="http://schemas.microsoft.com/office/drawing/2014/main" val="439150061"/>
                    </a:ext>
                  </a:extLst>
                </a:gridCol>
                <a:gridCol w="774131">
                  <a:extLst>
                    <a:ext uri="{9D8B030D-6E8A-4147-A177-3AD203B41FA5}">
                      <a16:colId xmlns:a16="http://schemas.microsoft.com/office/drawing/2014/main" val="1085071461"/>
                    </a:ext>
                  </a:extLst>
                </a:gridCol>
                <a:gridCol w="774131">
                  <a:extLst>
                    <a:ext uri="{9D8B030D-6E8A-4147-A177-3AD203B41FA5}">
                      <a16:colId xmlns:a16="http://schemas.microsoft.com/office/drawing/2014/main" val="2033557376"/>
                    </a:ext>
                  </a:extLst>
                </a:gridCol>
                <a:gridCol w="774131">
                  <a:extLst>
                    <a:ext uri="{9D8B030D-6E8A-4147-A177-3AD203B41FA5}">
                      <a16:colId xmlns:a16="http://schemas.microsoft.com/office/drawing/2014/main" val="1998996077"/>
                    </a:ext>
                  </a:extLst>
                </a:gridCol>
                <a:gridCol w="774131">
                  <a:extLst>
                    <a:ext uri="{9D8B030D-6E8A-4147-A177-3AD203B41FA5}">
                      <a16:colId xmlns:a16="http://schemas.microsoft.com/office/drawing/2014/main" val="3856391490"/>
                    </a:ext>
                  </a:extLst>
                </a:gridCol>
                <a:gridCol w="774131">
                  <a:extLst>
                    <a:ext uri="{9D8B030D-6E8A-4147-A177-3AD203B41FA5}">
                      <a16:colId xmlns:a16="http://schemas.microsoft.com/office/drawing/2014/main" val="1033911526"/>
                    </a:ext>
                  </a:extLst>
                </a:gridCol>
                <a:gridCol w="774131">
                  <a:extLst>
                    <a:ext uri="{9D8B030D-6E8A-4147-A177-3AD203B41FA5}">
                      <a16:colId xmlns:a16="http://schemas.microsoft.com/office/drawing/2014/main" val="1469257454"/>
                    </a:ext>
                  </a:extLst>
                </a:gridCol>
                <a:gridCol w="774131">
                  <a:extLst>
                    <a:ext uri="{9D8B030D-6E8A-4147-A177-3AD203B41FA5}">
                      <a16:colId xmlns:a16="http://schemas.microsoft.com/office/drawing/2014/main" val="2276587858"/>
                    </a:ext>
                  </a:extLst>
                </a:gridCol>
              </a:tblGrid>
              <a:tr h="343109"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ll phenotypes </a:t>
                      </a: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FACS analysis)</a:t>
                      </a:r>
                    </a:p>
                  </a:txBody>
                  <a:tcPr marL="31464" marR="31464" marT="21054" marB="2105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endParaRPr lang="en-US" sz="800" kern="0" spc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endParaRPr lang="en-US" sz="800" b="0" kern="0" spc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8">
                  <a:txBody>
                    <a:bodyPr/>
                    <a:lstStyle/>
                    <a:p>
                      <a:pPr marL="0" marR="0" indent="0" algn="ctr" defTabSz="1910547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10D-induced airway inflammation murine model (Absolute No.)</a:t>
                      </a:r>
                      <a:endParaRPr lang="en-US" sz="800" b="1" kern="0" spc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indent="0" algn="l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endParaRPr lang="en-US" sz="1000" kern="0" spc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927" marR="41927" marT="28055" marB="28055" anchor="ctr">
                    <a:lnL>
                      <a:noFill/>
                    </a:lnL>
                    <a:lnR>
                      <a:noFill/>
                    </a:lnR>
                    <a:lnT w="25146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indent="0" algn="l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endParaRPr lang="en-US" sz="1000" kern="0" spc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927" marR="41927" marT="28055" marB="28055" anchor="ctr">
                    <a:lnL>
                      <a:noFill/>
                    </a:lnL>
                    <a:lnR>
                      <a:noFill/>
                    </a:lnR>
                    <a:lnT w="25146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8097467"/>
                  </a:ext>
                </a:extLst>
              </a:tr>
              <a:tr h="37924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 b="1" kern="0" spc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</a:t>
                      </a: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M10D-CTL</a:t>
                      </a: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M10D-Dexa</a:t>
                      </a:r>
                    </a:p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 mg/kg</a:t>
                      </a:r>
                      <a:endParaRPr lang="en-US" altLang="ko-KR" sz="800" b="1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M10D-OFI-</a:t>
                      </a:r>
                    </a:p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 200 mg/kg</a:t>
                      </a:r>
                      <a:endParaRPr lang="en-US" altLang="ko-KR" sz="800" b="1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M10D-OFI-</a:t>
                      </a:r>
                    </a:p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 100 mg/kg</a:t>
                      </a:r>
                      <a:endParaRPr lang="en-US" sz="800" b="1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M10D-OFI-</a:t>
                      </a:r>
                    </a:p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0E 200 mg/kg</a:t>
                      </a:r>
                      <a:endParaRPr lang="en-US" altLang="ko-KR" sz="800" b="1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M10D-OFI-</a:t>
                      </a:r>
                    </a:p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0E 100 mg/kg</a:t>
                      </a:r>
                      <a:endParaRPr lang="en-US" sz="800" b="1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M10D-OFI-</a:t>
                      </a:r>
                    </a:p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E 200 mg/kg</a:t>
                      </a:r>
                      <a:endParaRPr lang="en-US" altLang="ko-KR" sz="800" b="1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M10D-OFI-</a:t>
                      </a:r>
                    </a:p>
                    <a:p>
                      <a:pPr marL="0" marR="0" indent="0" algn="ctr" fontAlgn="base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altLang="ko-KR" sz="800" b="1" kern="0" spc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E 100 mg/kg</a:t>
                      </a:r>
                      <a:endParaRPr lang="en-US" altLang="ko-KR" sz="800" b="1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66427069"/>
                  </a:ext>
                </a:extLst>
              </a:tr>
              <a:tr h="262657">
                <a:tc>
                  <a:txBody>
                    <a:bodyPr/>
                    <a:lstStyle/>
                    <a:p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ymphocyte (×10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cells)</a:t>
                      </a:r>
                      <a:endParaRPr lang="ko-KR" altLang="en-US" sz="80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ng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3.08±1.81</a:t>
                      </a:r>
                      <a:endParaRPr lang="en-US" sz="800" b="0" kern="0" spc="0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9.23±14.64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##</a:t>
                      </a:r>
                      <a:endParaRPr lang="en-US" altLang="ko-KR" sz="800" b="0" kern="0" spc="0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3.94±2.18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  <a:endParaRPr lang="en-US" altLang="ko-KR" sz="800" b="0" i="0" u="none" strike="noStrike" kern="1200" baseline="30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5.61±10.80</a:t>
                      </a:r>
                      <a:endParaRPr lang="en-US" altLang="ko-KR" sz="800" b="0" i="0" u="none" strike="noStrike" kern="1200" baseline="30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2.12±5.88</a:t>
                      </a:r>
                      <a:endParaRPr lang="en-US" altLang="ko-KR" sz="800" b="0" kern="0" spc="0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6.03±18.89</a:t>
                      </a:r>
                      <a:endParaRPr lang="en-US" sz="800" b="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8.39±12.14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5.82±4.67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5.34±11.68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47876968"/>
                  </a:ext>
                </a:extLst>
              </a:tr>
              <a:tr h="262657">
                <a:tc>
                  <a:txBody>
                    <a:bodyPr/>
                    <a:lstStyle/>
                    <a:p>
                      <a:pPr marL="0" marR="0" lvl="0" indent="0" algn="l" defTabSz="914433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eutrophils (×10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cells)</a:t>
                      </a:r>
                      <a:endParaRPr lang="ko-KR" altLang="en-US" sz="800" dirty="0">
                        <a:solidFill>
                          <a:srgbClr val="FF00FF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63±4.04</a:t>
                      </a:r>
                      <a:endParaRPr lang="en-US" altLang="ko-KR" sz="800" b="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3.50±7.81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##</a:t>
                      </a:r>
                      <a:endParaRPr lang="en-US" sz="800" b="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4.79±6.58</a:t>
                      </a:r>
                      <a:endParaRPr lang="en-US" sz="800" b="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5.68±8.54</a:t>
                      </a:r>
                      <a:endParaRPr lang="en-US" sz="800" b="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5.16±7.44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  <a:endParaRPr lang="en-US" sz="800" b="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2.20±1.97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.83±0.93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09±0.74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32±1.50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55019969"/>
                  </a:ext>
                </a:extLst>
              </a:tr>
              <a:tr h="262657">
                <a:tc>
                  <a:txBody>
                    <a:bodyPr/>
                    <a:lstStyle/>
                    <a:p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D3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CD4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(×10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cells)</a:t>
                      </a:r>
                      <a:endParaRPr lang="ko-KR" altLang="en-US" sz="80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5.10±1.11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3.80±14.24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##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7.8±2.52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1.37±11.08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6.27±6.24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8.04±13.81</a:t>
                      </a:r>
                      <a:endParaRPr lang="ko-KR" altLang="en-US" sz="800" b="0" i="0" u="none" strike="noStrike" kern="12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4.77±5.99</a:t>
                      </a:r>
                      <a:endParaRPr lang="ko-KR" altLang="en-US" sz="800" b="0" i="0" u="none" strike="noStrike" kern="12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1.07±3.05</a:t>
                      </a:r>
                      <a:endParaRPr lang="ko-KR" altLang="en-US" sz="800" b="0" i="0" u="none" strike="noStrike" kern="12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4.56±5.34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  <a:endParaRPr lang="ko-KR" altLang="en-US" sz="800" b="0" i="0" u="none" strike="noStrike" kern="12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94278017"/>
                  </a:ext>
                </a:extLst>
              </a:tr>
              <a:tr h="262657">
                <a:tc>
                  <a:txBody>
                    <a:bodyPr/>
                    <a:lstStyle/>
                    <a:p>
                      <a:pPr marL="0" marR="0" lvl="0" indent="0" algn="l" defTabSz="914433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D3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CD8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(×10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cells)</a:t>
                      </a:r>
                      <a:endParaRPr lang="ko-KR" altLang="en-US" sz="800" dirty="0">
                        <a:solidFill>
                          <a:srgbClr val="FF00FF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55±1.09</a:t>
                      </a:r>
                      <a:endParaRPr lang="en-US" sz="800" b="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4.23±4.27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###</a:t>
                      </a:r>
                      <a:endParaRPr lang="en-US" altLang="ko-KR" sz="800" b="0" kern="0" spc="0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.36±1.98</a:t>
                      </a:r>
                      <a:endParaRPr lang="en-US" altLang="ko-KR" sz="800" b="0" kern="0" spc="0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.03±3.74</a:t>
                      </a:r>
                      <a:endParaRPr lang="en-US" altLang="ko-KR" sz="800" b="0" kern="0" spc="0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9.27±2.86</a:t>
                      </a:r>
                      <a:endParaRPr lang="ko-KR" altLang="en-US" sz="8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5.41±5.23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70±1.24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07±0.44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  <a:endParaRPr lang="en-US" altLang="ko-KR" sz="800" b="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05±1.16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44387271"/>
                  </a:ext>
                </a:extLst>
              </a:tr>
              <a:tr h="26265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r-1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CD11b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(×10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cells)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83±0.35</a:t>
                      </a:r>
                      <a:endParaRPr lang="en-US" sz="800" b="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8.35±7.57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###</a:t>
                      </a:r>
                      <a:endParaRPr lang="en-US" altLang="ko-KR" sz="800" b="0" kern="0" spc="0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86±1.18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  <a:endParaRPr lang="en-US" altLang="ko-KR" sz="800" b="0" kern="0" spc="0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.11±1.38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  <a:endParaRPr lang="en-US" altLang="ko-KR" sz="800" b="0" kern="0" spc="0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67±4.86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  <a:endParaRPr lang="ko-KR" altLang="en-US" sz="8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96±0.31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51±2.94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80±0.32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32±1.14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52583697"/>
                  </a:ext>
                </a:extLst>
              </a:tr>
              <a:tr h="262657">
                <a:tc>
                  <a:txBody>
                    <a:bodyPr/>
                    <a:lstStyle/>
                    <a:p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D3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CD4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(×10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cells)</a:t>
                      </a:r>
                      <a:endParaRPr lang="ko-KR" altLang="en-US" sz="8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-16527780" algn="l"/>
                          <a:tab pos="-16019780" algn="l"/>
                          <a:tab pos="-15511780" algn="l"/>
                          <a:tab pos="-15003780" algn="l"/>
                          <a:tab pos="-14495780" algn="l"/>
                          <a:tab pos="-13987780" algn="l"/>
                          <a:tab pos="-13479780" algn="l"/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</a:tabLst>
                        <a:defRPr/>
                      </a:pPr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LF</a:t>
                      </a:r>
                      <a:endParaRPr lang="en-US" sz="800" kern="0" spc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2±0.02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6.00±1.90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###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7±2.57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.00±1.61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.66±2.52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8.45±1.37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9.33±10.00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96±2.33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63±1.67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73791698"/>
                  </a:ext>
                </a:extLst>
              </a:tr>
              <a:tr h="262657">
                <a:tc>
                  <a:txBody>
                    <a:bodyPr/>
                    <a:lstStyle/>
                    <a:p>
                      <a:pPr marL="0" marR="0" lvl="0" indent="0" algn="l" defTabSz="914433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D3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CD8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(×10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cells)</a:t>
                      </a:r>
                      <a:endParaRPr lang="ko-KR" altLang="en-US" sz="800" dirty="0">
                        <a:solidFill>
                          <a:srgbClr val="FF00FF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±0.01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4.25±2.90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###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±0.28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52±3.24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92±3.76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.33±9.65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96±1.82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77±2.09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50±1.65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  <a:endParaRPr kumimoji="0" lang="en-US" altLang="ko-KR" sz="8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29413266"/>
                  </a:ext>
                </a:extLst>
              </a:tr>
              <a:tr h="26265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r-1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CD11b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(×10</a:t>
                      </a:r>
                      <a:r>
                        <a:rPr lang="en-US" altLang="ko-KR" sz="800" b="0" i="0" u="none" strike="noStrike" kern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altLang="ko-KR" sz="800" b="0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cells)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8±0.00</a:t>
                      </a:r>
                      <a:endParaRPr lang="en-US" sz="800" b="0" kern="0" spc="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6.72±1.80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###</a:t>
                      </a:r>
                      <a:endParaRPr lang="en-US" altLang="ko-KR" sz="800" b="0" kern="0" spc="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74±0.98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lang="en-US" altLang="ko-KR" sz="800" b="0" kern="0" spc="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4.72±23.55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</a:t>
                      </a:r>
                      <a:endParaRPr lang="en-US" altLang="ko-KR" sz="800" b="0" kern="0" spc="0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3.18±2.53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lang="ko-KR" altLang="en-US" sz="8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464" marR="31464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5.46±10.46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5.02±5.71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3.5±18.25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3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0.46±14.24</a:t>
                      </a:r>
                      <a:r>
                        <a:rPr kumimoji="0" lang="en-US" altLang="ko-KR" sz="8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***</a:t>
                      </a:r>
                      <a:endParaRPr lang="en-US" altLang="ko-KR" sz="800" kern="0" spc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582" marR="31582" marT="21054" marB="2105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25062488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708089" y="4577826"/>
            <a:ext cx="8634911" cy="4458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: </a:t>
            </a:r>
            <a:r>
              <a:rPr lang="en-GB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LB/c n</a:t>
            </a:r>
            <a:r>
              <a:rPr lang="en-US" altLang="ko-KR" sz="766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mal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 group; CTL: </a:t>
            </a:r>
            <a:r>
              <a:rPr lang="en-GB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10D-induced control group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altLang="ko-KR" sz="766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xa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mg/kg dexamethasone-treated PM10D-induced group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OFI-W 100 and 200: </a:t>
            </a:r>
            <a:r>
              <a:rPr lang="en-GB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10D-induced group treated with 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and 200</a:t>
            </a:r>
            <a:r>
              <a:rPr lang="en-GB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g/kg 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I-water extract</a:t>
            </a:r>
            <a:r>
              <a:rPr lang="en-GB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; 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I-30E 100 and 200: </a:t>
            </a:r>
            <a:r>
              <a:rPr lang="en-GB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10D-induced group treated with 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and 200</a:t>
            </a:r>
            <a:r>
              <a:rPr lang="en-GB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g/kg 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I-30% ethanol extract</a:t>
            </a:r>
            <a:r>
              <a:rPr lang="en-GB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;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I-50E 100 and 200: </a:t>
            </a:r>
            <a:r>
              <a:rPr lang="en-GB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10D-induced group treated with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0 and 200</a:t>
            </a:r>
            <a:r>
              <a:rPr lang="en-GB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g/kg 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I-50% ethanol extract</a:t>
            </a:r>
            <a:r>
              <a:rPr lang="en-GB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. Data are expressed as means ± SEM, n = 8. </a:t>
            </a:r>
            <a:r>
              <a:rPr lang="en-US" altLang="ko-KR" sz="766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##</a:t>
            </a:r>
            <a:r>
              <a:rPr lang="en-US" altLang="ko-KR" sz="766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5 vs NC; </a:t>
            </a:r>
            <a:r>
              <a:rPr lang="en-US" altLang="ko-KR" sz="766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ko-KR" sz="766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, </a:t>
            </a:r>
            <a:r>
              <a:rPr lang="en-US" altLang="ko-KR" sz="766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altLang="ko-KR" sz="766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, and </a:t>
            </a:r>
            <a:r>
              <a:rPr lang="en-US" altLang="ko-KR" sz="766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altLang="ko-KR" sz="766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76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5 vs CTL. </a:t>
            </a:r>
            <a:endParaRPr lang="ko-KR" altLang="ko-KR" sz="76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1888928" y="1140455"/>
            <a:ext cx="8454072" cy="6228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49" b="1" dirty="0"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Table</a:t>
            </a:r>
            <a:r>
              <a:rPr lang="ko-KR" altLang="en-US" sz="1149" b="1" dirty="0"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149" b="1" dirty="0"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S1</a:t>
            </a:r>
            <a:r>
              <a:rPr lang="en-US" altLang="ko-KR" sz="114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ffects of water and ethanolic extracts of OFI on airway immune cell number and neutrophilic airway inflammation in a PM10-induced airway inflammation model.</a:t>
            </a:r>
            <a:endParaRPr lang="ko-KR" altLang="ko-KR" sz="114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ko-KR" sz="114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341831" y="299208"/>
            <a:ext cx="1980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Supplement dat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7025524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103A7B7-A985-4AE6-8AE5-B0C2C9D6AC46}"/>
              </a:ext>
            </a:extLst>
          </p:cNvPr>
          <p:cNvSpPr txBox="1"/>
          <p:nvPr/>
        </p:nvSpPr>
        <p:spPr>
          <a:xfrm>
            <a:off x="465827" y="422695"/>
            <a:ext cx="22433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Supplementary Figure S1</a:t>
            </a:r>
            <a:endParaRPr lang="ko-KR" altLang="en-US" sz="1400" dirty="0"/>
          </a:p>
        </p:txBody>
      </p:sp>
      <p:grpSp>
        <p:nvGrpSpPr>
          <p:cNvPr id="6" name="그룹 5"/>
          <p:cNvGrpSpPr/>
          <p:nvPr/>
        </p:nvGrpSpPr>
        <p:grpSpPr>
          <a:xfrm>
            <a:off x="1768979" y="2230452"/>
            <a:ext cx="8160122" cy="2763825"/>
            <a:chOff x="1768979" y="2230452"/>
            <a:chExt cx="8160122" cy="2763825"/>
          </a:xfrm>
        </p:grpSpPr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F40AF538-94D0-44F5-8157-E2858DFB19A6}"/>
                </a:ext>
              </a:extLst>
            </p:cNvPr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3036"/>
            <a:stretch/>
          </p:blipFill>
          <p:spPr bwMode="auto">
            <a:xfrm>
              <a:off x="1768979" y="2230452"/>
              <a:ext cx="8160122" cy="2107749"/>
            </a:xfrm>
            <a:prstGeom prst="rect">
              <a:avLst/>
            </a:prstGeom>
            <a:noFill/>
          </p:spPr>
        </p:pic>
        <p:sp>
          <p:nvSpPr>
            <p:cNvPr id="2" name="TextBox 1"/>
            <p:cNvSpPr txBox="1"/>
            <p:nvPr/>
          </p:nvSpPr>
          <p:spPr>
            <a:xfrm>
              <a:off x="2170631" y="4717278"/>
              <a:ext cx="58560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S1.  Scheme of PM10D sensitization and challenge protocol.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직사각형 2"/>
            <p:cNvSpPr/>
            <p:nvPr/>
          </p:nvSpPr>
          <p:spPr>
            <a:xfrm>
              <a:off x="2025353" y="2315910"/>
              <a:ext cx="552399" cy="341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949255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404</Words>
  <Application>Microsoft Office PowerPoint</Application>
  <PresentationFormat>Widescreen</PresentationFormat>
  <Paragraphs>10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맑은 고딕</vt:lpstr>
      <vt:lpstr>함초롬바탕</vt:lpstr>
      <vt:lpstr>Arial</vt:lpstr>
      <vt:lpstr>Times New Roman</vt:lpstr>
      <vt:lpstr>Office 테마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heeys04@naver.com</dc:creator>
  <cp:lastModifiedBy>MDPI</cp:lastModifiedBy>
  <cp:revision>8</cp:revision>
  <dcterms:created xsi:type="dcterms:W3CDTF">2021-07-19T12:42:48Z</dcterms:created>
  <dcterms:modified xsi:type="dcterms:W3CDTF">2022-02-16T07:07:09Z</dcterms:modified>
</cp:coreProperties>
</file>